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1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02474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41851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809458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590625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109709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4900212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54094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16372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557907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12167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176033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13851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t="4341" r="25093"/>
          <a:stretch/>
        </p:blipFill>
        <p:spPr>
          <a:xfrm>
            <a:off x="1573849" y="1367380"/>
            <a:ext cx="6093199" cy="459217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620448" y="4042140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K-19 </a:t>
            </a:r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+)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597667" y="3314080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K-19 </a:t>
            </a:r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006419" y="1543650"/>
            <a:ext cx="1987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039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3411" y="188259"/>
            <a:ext cx="1801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A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81001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t="4902" r="24927"/>
          <a:stretch/>
        </p:blipFill>
        <p:spPr>
          <a:xfrm>
            <a:off x="2001064" y="1243389"/>
            <a:ext cx="6106646" cy="456527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332381" y="3202862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44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CD24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 </a:t>
            </a:r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-)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838237" y="4077136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44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CD24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+)</a:t>
            </a:r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060474" y="1304364"/>
            <a:ext cx="1987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004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3411" y="188259"/>
            <a:ext cx="1801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B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45888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t="3221" r="24927"/>
          <a:stretch/>
        </p:blipFill>
        <p:spPr>
          <a:xfrm>
            <a:off x="2028825" y="1183340"/>
            <a:ext cx="6106646" cy="464595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082148" y="3204324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DH1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CD24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 </a:t>
            </a:r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-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138387" y="4678076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DH1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CD24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 </a:t>
            </a:r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+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296765" y="1476849"/>
            <a:ext cx="1987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014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3411" y="188259"/>
            <a:ext cx="1801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C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02604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t="6022" r="25423"/>
          <a:stretch/>
        </p:blipFill>
        <p:spPr>
          <a:xfrm>
            <a:off x="2028825" y="1317812"/>
            <a:ext cx="6066304" cy="451148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931612" y="3117358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858494" y="4251234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 (+)</a:t>
            </a:r>
            <a:endParaRPr lang="el-GR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381127" y="1533330"/>
            <a:ext cx="1987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041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3411" y="188259"/>
            <a:ext cx="1801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D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14185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36</Words>
  <Application>Microsoft Office PowerPoint</Application>
  <PresentationFormat>Widescreen</PresentationFormat>
  <Paragraphs>1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eti Strati</dc:creator>
  <cp:lastModifiedBy>Areti Strati</cp:lastModifiedBy>
  <cp:revision>6</cp:revision>
  <dcterms:created xsi:type="dcterms:W3CDTF">2021-03-07T20:31:20Z</dcterms:created>
  <dcterms:modified xsi:type="dcterms:W3CDTF">2021-03-13T11:34:14Z</dcterms:modified>
</cp:coreProperties>
</file>